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tiff" ContentType="image/tiff"/>
  <Default Extension="vml" ContentType="application/vnd.openxmlformats-officedocument.vmlDrawing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58" r:id="rId2"/>
    <p:sldId id="261" r:id="rId3"/>
    <p:sldId id="259" r:id="rId4"/>
    <p:sldId id="260" r:id="rId5"/>
    <p:sldId id="262" r:id="rId6"/>
  </p:sldIdLst>
  <p:sldSz cx="9144000" cy="6858000" type="screen4x3"/>
  <p:notesSz cx="6858000" cy="9144000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9" d="100"/>
          <a:sy n="69" d="100"/>
        </p:scale>
        <p:origin x="600" y="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13.emf"/><Relationship Id="rId3" Type="http://schemas.openxmlformats.org/officeDocument/2006/relationships/image" Target="../media/image8.emf"/><Relationship Id="rId7" Type="http://schemas.openxmlformats.org/officeDocument/2006/relationships/image" Target="../media/image12.emf"/><Relationship Id="rId12" Type="http://schemas.openxmlformats.org/officeDocument/2006/relationships/image" Target="../media/image17.emf"/><Relationship Id="rId2" Type="http://schemas.openxmlformats.org/officeDocument/2006/relationships/image" Target="../media/image7.emf"/><Relationship Id="rId1" Type="http://schemas.openxmlformats.org/officeDocument/2006/relationships/image" Target="../media/image6.emf"/><Relationship Id="rId6" Type="http://schemas.openxmlformats.org/officeDocument/2006/relationships/image" Target="../media/image11.emf"/><Relationship Id="rId11" Type="http://schemas.openxmlformats.org/officeDocument/2006/relationships/image" Target="../media/image16.emf"/><Relationship Id="rId5" Type="http://schemas.openxmlformats.org/officeDocument/2006/relationships/image" Target="../media/image10.emf"/><Relationship Id="rId10" Type="http://schemas.openxmlformats.org/officeDocument/2006/relationships/image" Target="../media/image15.emf"/><Relationship Id="rId4" Type="http://schemas.openxmlformats.org/officeDocument/2006/relationships/image" Target="../media/image9.emf"/><Relationship Id="rId9" Type="http://schemas.openxmlformats.org/officeDocument/2006/relationships/image" Target="../media/image1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хний колонтитул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ru-RU"/>
          </a:p>
        </p:txBody>
      </p:sp>
      <p:sp>
        <p:nvSpPr>
          <p:cNvPr id="3" name="Дата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5920566-EAD3-48E8-8951-FE96F080E31E}" type="datetimeFigureOut">
              <a:rPr lang="ru-RU" smtClean="0"/>
              <a:t>12.11.2022</a:t>
            </a:fld>
            <a:endParaRPr lang="ru-RU"/>
          </a:p>
        </p:txBody>
      </p:sp>
      <p:sp>
        <p:nvSpPr>
          <p:cNvPr id="4" name="Образ слайда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ru-RU"/>
          </a:p>
        </p:txBody>
      </p:sp>
      <p:sp>
        <p:nvSpPr>
          <p:cNvPr id="5" name="Заметки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805C12D-AD5E-4407-A6E3-EDC1115132C5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9174088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Образ слайда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Заметки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ru-RU" dirty="0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805C12D-AD5E-4407-A6E3-EDC1115132C5}" type="slidenum">
              <a:rPr lang="ru-RU" smtClean="0"/>
              <a:t>5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59214738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Подзаголовок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ru-RU" smtClean="0"/>
              <a:t>Образец подзаголовка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26E4C3-32BA-424F-BEB3-25EC354F6240}" type="datetimeFigureOut">
              <a:rPr lang="ru-RU" smtClean="0"/>
              <a:t>12.11.2022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459C8-F875-402D-A675-4D2B2B229E8A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6743886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26E4C3-32BA-424F-BEB3-25EC354F6240}" type="datetimeFigureOut">
              <a:rPr lang="ru-RU" smtClean="0"/>
              <a:t>12.11.2022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459C8-F875-402D-A675-4D2B2B229E8A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6466965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26E4C3-32BA-424F-BEB3-25EC354F6240}" type="datetimeFigureOut">
              <a:rPr lang="ru-RU" smtClean="0"/>
              <a:t>12.11.2022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459C8-F875-402D-A675-4D2B2B229E8A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7058045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Объект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26E4C3-32BA-424F-BEB3-25EC354F6240}" type="datetimeFigureOut">
              <a:rPr lang="ru-RU" smtClean="0"/>
              <a:t>12.11.2022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459C8-F875-402D-A675-4D2B2B229E8A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6495850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26E4C3-32BA-424F-BEB3-25EC354F6240}" type="datetimeFigureOut">
              <a:rPr lang="ru-RU" smtClean="0"/>
              <a:t>12.11.2022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459C8-F875-402D-A675-4D2B2B229E8A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4478910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Объект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Объект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26E4C3-32BA-424F-BEB3-25EC354F6240}" type="datetimeFigureOut">
              <a:rPr lang="ru-RU" smtClean="0"/>
              <a:t>12.11.2022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459C8-F875-402D-A675-4D2B2B229E8A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999207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Объект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Текст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6" name="Объект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7" name="Дата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26E4C3-32BA-424F-BEB3-25EC354F6240}" type="datetimeFigureOut">
              <a:rPr lang="ru-RU" smtClean="0"/>
              <a:t>12.11.2022</a:t>
            </a:fld>
            <a:endParaRPr lang="ru-RU"/>
          </a:p>
        </p:txBody>
      </p:sp>
      <p:sp>
        <p:nvSpPr>
          <p:cNvPr id="8" name="Нижний колонтитул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Номер слайда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459C8-F875-402D-A675-4D2B2B229E8A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7437118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Дата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26E4C3-32BA-424F-BEB3-25EC354F6240}" type="datetimeFigureOut">
              <a:rPr lang="ru-RU" smtClean="0"/>
              <a:t>12.11.2022</a:t>
            </a:fld>
            <a:endParaRPr lang="ru-RU"/>
          </a:p>
        </p:txBody>
      </p:sp>
      <p:sp>
        <p:nvSpPr>
          <p:cNvPr id="4" name="Нижний колонтитул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Номер слайда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459C8-F875-402D-A675-4D2B2B229E8A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3228487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26E4C3-32BA-424F-BEB3-25EC354F6240}" type="datetimeFigureOut">
              <a:rPr lang="ru-RU" smtClean="0"/>
              <a:t>12.11.2022</a:t>
            </a:fld>
            <a:endParaRPr lang="ru-RU"/>
          </a:p>
        </p:txBody>
      </p:sp>
      <p:sp>
        <p:nvSpPr>
          <p:cNvPr id="3" name="Нижний колонтитул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459C8-F875-402D-A675-4D2B2B229E8A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4009656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Объект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26E4C3-32BA-424F-BEB3-25EC354F6240}" type="datetimeFigureOut">
              <a:rPr lang="ru-RU" smtClean="0"/>
              <a:t>12.11.2022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459C8-F875-402D-A675-4D2B2B229E8A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7735941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Рисунок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26E4C3-32BA-424F-BEB3-25EC354F6240}" type="datetimeFigureOut">
              <a:rPr lang="ru-RU" smtClean="0"/>
              <a:t>12.11.2022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459C8-F875-402D-A675-4D2B2B229E8A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3993891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26E4C3-32BA-424F-BEB3-25EC354F6240}" type="datetimeFigureOut">
              <a:rPr lang="ru-RU" smtClean="0"/>
              <a:t>12.11.2022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B459C8-F875-402D-A675-4D2B2B229E8A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5490041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u-R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13" Type="http://schemas.openxmlformats.org/officeDocument/2006/relationships/image" Target="../media/image10.emf"/><Relationship Id="rId18" Type="http://schemas.openxmlformats.org/officeDocument/2006/relationships/oleObject" Target="../embeddings/oleObject8.bin"/><Relationship Id="rId26" Type="http://schemas.openxmlformats.org/officeDocument/2006/relationships/oleObject" Target="../embeddings/oleObject12.bin"/><Relationship Id="rId3" Type="http://schemas.openxmlformats.org/officeDocument/2006/relationships/notesSlide" Target="../notesSlides/notesSlide1.xml"/><Relationship Id="rId21" Type="http://schemas.openxmlformats.org/officeDocument/2006/relationships/image" Target="../media/image14.emf"/><Relationship Id="rId7" Type="http://schemas.openxmlformats.org/officeDocument/2006/relationships/image" Target="../media/image7.emf"/><Relationship Id="rId12" Type="http://schemas.openxmlformats.org/officeDocument/2006/relationships/oleObject" Target="../embeddings/oleObject5.bin"/><Relationship Id="rId17" Type="http://schemas.openxmlformats.org/officeDocument/2006/relationships/image" Target="../media/image12.emf"/><Relationship Id="rId25" Type="http://schemas.openxmlformats.org/officeDocument/2006/relationships/image" Target="../media/image16.emf"/><Relationship Id="rId2" Type="http://schemas.openxmlformats.org/officeDocument/2006/relationships/slideLayout" Target="../slideLayouts/slideLayout7.xml"/><Relationship Id="rId16" Type="http://schemas.openxmlformats.org/officeDocument/2006/relationships/oleObject" Target="../embeddings/oleObject7.bin"/><Relationship Id="rId20" Type="http://schemas.openxmlformats.org/officeDocument/2006/relationships/oleObject" Target="../embeddings/oleObject9.bin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9.emf"/><Relationship Id="rId24" Type="http://schemas.openxmlformats.org/officeDocument/2006/relationships/oleObject" Target="../embeddings/oleObject11.bin"/><Relationship Id="rId5" Type="http://schemas.openxmlformats.org/officeDocument/2006/relationships/image" Target="../media/image6.emf"/><Relationship Id="rId15" Type="http://schemas.openxmlformats.org/officeDocument/2006/relationships/image" Target="../media/image11.emf"/><Relationship Id="rId23" Type="http://schemas.openxmlformats.org/officeDocument/2006/relationships/image" Target="../media/image15.emf"/><Relationship Id="rId10" Type="http://schemas.openxmlformats.org/officeDocument/2006/relationships/oleObject" Target="../embeddings/oleObject4.bin"/><Relationship Id="rId19" Type="http://schemas.openxmlformats.org/officeDocument/2006/relationships/image" Target="../media/image13.emf"/><Relationship Id="rId4" Type="http://schemas.openxmlformats.org/officeDocument/2006/relationships/oleObject" Target="../embeddings/oleObject1.bin"/><Relationship Id="rId9" Type="http://schemas.openxmlformats.org/officeDocument/2006/relationships/image" Target="../media/image8.emf"/><Relationship Id="rId14" Type="http://schemas.openxmlformats.org/officeDocument/2006/relationships/oleObject" Target="../embeddings/oleObject6.bin"/><Relationship Id="rId22" Type="http://schemas.openxmlformats.org/officeDocument/2006/relationships/oleObject" Target="../embeddings/oleObject10.bin"/><Relationship Id="rId27" Type="http://schemas.openxmlformats.org/officeDocument/2006/relationships/image" Target="../media/image1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Прямоугольник 3"/>
          <p:cNvSpPr/>
          <p:nvPr/>
        </p:nvSpPr>
        <p:spPr>
          <a:xfrm>
            <a:off x="827584" y="3228945"/>
            <a:ext cx="7416824" cy="190821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Tailoring of dissimilar friction-stir lap welding of aluminum and titanium</a:t>
            </a:r>
            <a:endParaRPr lang="ru-RU" sz="3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ru-RU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Alexander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Kalinenko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, Pavel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Dolzhenko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Yuli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Borisova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endParaRPr lang="ru-RU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ergey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Malopheyev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, Sergey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Mironov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, Rustam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Kaibyshev</a:t>
            </a:r>
            <a:endParaRPr lang="ru-RU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383298" y="1196752"/>
            <a:ext cx="8784976" cy="135421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4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materials for the article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  <a:endParaRPr lang="en-US" sz="14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50491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Группа 10"/>
          <p:cNvGrpSpPr/>
          <p:nvPr/>
        </p:nvGrpSpPr>
        <p:grpSpPr>
          <a:xfrm>
            <a:off x="0" y="526473"/>
            <a:ext cx="9102436" cy="5084618"/>
            <a:chOff x="0" y="526473"/>
            <a:chExt cx="9102436" cy="5084618"/>
          </a:xfrm>
        </p:grpSpPr>
        <p:sp>
          <p:nvSpPr>
            <p:cNvPr id="10" name="Прямоугольник 9"/>
            <p:cNvSpPr/>
            <p:nvPr/>
          </p:nvSpPr>
          <p:spPr>
            <a:xfrm>
              <a:off x="0" y="526473"/>
              <a:ext cx="9102436" cy="508461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ru-RU"/>
            </a:p>
          </p:txBody>
        </p:sp>
        <p:grpSp>
          <p:nvGrpSpPr>
            <p:cNvPr id="9" name="Группа 8"/>
            <p:cNvGrpSpPr/>
            <p:nvPr/>
          </p:nvGrpSpPr>
          <p:grpSpPr>
            <a:xfrm>
              <a:off x="74468" y="595746"/>
              <a:ext cx="8958321" cy="4920000"/>
              <a:chOff x="74468" y="595746"/>
              <a:chExt cx="8958321" cy="4920000"/>
            </a:xfrm>
          </p:grpSpPr>
          <p:grpSp>
            <p:nvGrpSpPr>
              <p:cNvPr id="6" name="Группа 5"/>
              <p:cNvGrpSpPr/>
              <p:nvPr/>
            </p:nvGrpSpPr>
            <p:grpSpPr>
              <a:xfrm>
                <a:off x="74468" y="595746"/>
                <a:ext cx="3690000" cy="4920000"/>
                <a:chOff x="74468" y="595746"/>
                <a:chExt cx="3690000" cy="4920000"/>
              </a:xfrm>
            </p:grpSpPr>
            <p:pic>
              <p:nvPicPr>
                <p:cNvPr id="2" name="Рисунок 1"/>
                <p:cNvPicPr>
                  <a:picLocks noChangeAspect="1"/>
                </p:cNvPicPr>
                <p:nvPr/>
              </p:nvPicPr>
              <p:blipFill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74468" y="595746"/>
                  <a:ext cx="3690000" cy="4920000"/>
                </a:xfrm>
                <a:prstGeom prst="rect">
                  <a:avLst/>
                </a:prstGeom>
                <a:ln w="3175">
                  <a:solidFill>
                    <a:schemeClr val="tx1"/>
                  </a:solidFill>
                </a:ln>
              </p:spPr>
            </p:pic>
            <p:sp>
              <p:nvSpPr>
                <p:cNvPr id="4" name="TextBox 3"/>
                <p:cNvSpPr txBox="1"/>
                <p:nvPr/>
              </p:nvSpPr>
              <p:spPr>
                <a:xfrm>
                  <a:off x="87148" y="606329"/>
                  <a:ext cx="376706" cy="369332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lIns="0" tIns="0" rIns="0" bIns="0" rtlCol="0">
                  <a:spAutoFit/>
                </a:bodyPr>
                <a:lstStyle/>
                <a:p>
                  <a:r>
                    <a:rPr lang="ru-RU" sz="24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(</a:t>
                  </a:r>
                  <a:r>
                    <a:rPr lang="en-US" sz="24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a)</a:t>
                  </a:r>
                  <a:endParaRPr lang="ru-RU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7" name="Группа 6"/>
              <p:cNvGrpSpPr/>
              <p:nvPr/>
            </p:nvGrpSpPr>
            <p:grpSpPr>
              <a:xfrm>
                <a:off x="3891588" y="600410"/>
                <a:ext cx="5130000" cy="2885625"/>
                <a:chOff x="3906982" y="621723"/>
                <a:chExt cx="5130000" cy="2885625"/>
              </a:xfrm>
            </p:grpSpPr>
            <p:pic>
              <p:nvPicPr>
                <p:cNvPr id="3" name="Рисунок 2"/>
                <p:cNvPicPr>
                  <a:picLocks noChangeAspect="1"/>
                </p:cNvPicPr>
                <p:nvPr/>
              </p:nvPicPr>
              <p:blipFill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906982" y="621723"/>
                  <a:ext cx="5130000" cy="2885625"/>
                </a:xfrm>
                <a:prstGeom prst="rect">
                  <a:avLst/>
                </a:prstGeom>
                <a:ln w="3175">
                  <a:solidFill>
                    <a:schemeClr val="tx1"/>
                  </a:solidFill>
                </a:ln>
              </p:spPr>
            </p:pic>
            <p:sp>
              <p:nvSpPr>
                <p:cNvPr id="5" name="TextBox 4"/>
                <p:cNvSpPr txBox="1"/>
                <p:nvPr/>
              </p:nvSpPr>
              <p:spPr>
                <a:xfrm>
                  <a:off x="3924437" y="640134"/>
                  <a:ext cx="392736" cy="369332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lIns="0" tIns="0" rIns="0" bIns="0" rtlCol="0">
                  <a:spAutoFit/>
                </a:bodyPr>
                <a:lstStyle/>
                <a:p>
                  <a:r>
                    <a:rPr lang="ru-RU" sz="24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(</a:t>
                  </a:r>
                  <a:r>
                    <a:rPr lang="en-US" sz="2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</a:t>
                  </a:r>
                  <a:r>
                    <a:rPr lang="en-US" sz="24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)</a:t>
                  </a:r>
                  <a:endParaRPr lang="ru-RU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8" name="TextBox 7"/>
              <p:cNvSpPr txBox="1"/>
              <p:nvPr/>
            </p:nvSpPr>
            <p:spPr>
              <a:xfrm>
                <a:off x="3898895" y="3780064"/>
                <a:ext cx="5133894" cy="55399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just"/>
                <a:r>
                  <a:rPr lang="en-US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upplementary Figure </a:t>
                </a:r>
                <a:r>
                  <a:rPr lang="en-US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  <a:r>
                  <a:rPr lang="en-US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r>
                  <a:rPr lang="en-US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. (a) FSW machine and (b) experiment setup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62994748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79512" y="5942496"/>
            <a:ext cx="8784976" cy="276999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ru-RU" b="1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chematic showing the thermocouple layout. Scale: mm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2" descr="C:\Users\Sergey\Desktop\Paper\Supplementary\images\FSW scheme.tif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582"/>
          <a:stretch/>
        </p:blipFill>
        <p:spPr bwMode="auto">
          <a:xfrm>
            <a:off x="952437" y="153909"/>
            <a:ext cx="7200000" cy="548451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80568815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xtBox 21"/>
          <p:cNvSpPr txBox="1"/>
          <p:nvPr/>
        </p:nvSpPr>
        <p:spPr>
          <a:xfrm>
            <a:off x="1" y="6429804"/>
            <a:ext cx="9153474" cy="200055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3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sz="13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ru-RU" sz="13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13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Schematic showing specimens for lap-shear tests: (a) placement, (b) design. Scale: mm</a:t>
            </a:r>
          </a:p>
        </p:txBody>
      </p:sp>
      <p:grpSp>
        <p:nvGrpSpPr>
          <p:cNvPr id="11" name="Группа 10"/>
          <p:cNvGrpSpPr/>
          <p:nvPr/>
        </p:nvGrpSpPr>
        <p:grpSpPr>
          <a:xfrm>
            <a:off x="1259632" y="0"/>
            <a:ext cx="6360368" cy="6276109"/>
            <a:chOff x="1259632" y="0"/>
            <a:chExt cx="6360368" cy="6276109"/>
          </a:xfrm>
        </p:grpSpPr>
        <p:sp>
          <p:nvSpPr>
            <p:cNvPr id="10" name="Прямоугольник 9"/>
            <p:cNvSpPr/>
            <p:nvPr/>
          </p:nvSpPr>
          <p:spPr>
            <a:xfrm>
              <a:off x="1259632" y="0"/>
              <a:ext cx="6360368" cy="627610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ru-RU"/>
            </a:p>
          </p:txBody>
        </p:sp>
        <p:grpSp>
          <p:nvGrpSpPr>
            <p:cNvPr id="12" name="Группа 11"/>
            <p:cNvGrpSpPr/>
            <p:nvPr/>
          </p:nvGrpSpPr>
          <p:grpSpPr>
            <a:xfrm>
              <a:off x="1387256" y="32402"/>
              <a:ext cx="6065063" cy="3634252"/>
              <a:chOff x="1387256" y="32402"/>
              <a:chExt cx="6065063" cy="3634252"/>
            </a:xfrm>
          </p:grpSpPr>
          <p:pic>
            <p:nvPicPr>
              <p:cNvPr id="6" name="Picture 2" descr="C:\Users\Sergey\Desktop\Paper\Supplementary\images\Al-Ti plates with dog bone samples.tif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-3309" t="11064" r="-5803" b="7897"/>
              <a:stretch/>
            </p:blipFill>
            <p:spPr bwMode="auto">
              <a:xfrm>
                <a:off x="1387256" y="32402"/>
                <a:ext cx="6065063" cy="3634252"/>
              </a:xfrm>
              <a:prstGeom prst="rect">
                <a:avLst/>
              </a:prstGeom>
              <a:noFill/>
              <a:ln w="3175"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7" name="TextBox 6"/>
              <p:cNvSpPr txBox="1"/>
              <p:nvPr/>
            </p:nvSpPr>
            <p:spPr>
              <a:xfrm>
                <a:off x="1418799" y="59734"/>
                <a:ext cx="312586" cy="3077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just"/>
                <a:r>
                  <a:rPr lang="en-US" sz="2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a)</a:t>
                </a:r>
                <a:endParaRPr lang="ru-RU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8" name="Группа 7"/>
            <p:cNvGrpSpPr/>
            <p:nvPr/>
          </p:nvGrpSpPr>
          <p:grpSpPr>
            <a:xfrm>
              <a:off x="1387255" y="3861542"/>
              <a:ext cx="6065064" cy="2292096"/>
              <a:chOff x="1387255" y="3861542"/>
              <a:chExt cx="6065064" cy="2292096"/>
            </a:xfrm>
          </p:grpSpPr>
          <p:grpSp>
            <p:nvGrpSpPr>
              <p:cNvPr id="3" name="Группа 2"/>
              <p:cNvGrpSpPr/>
              <p:nvPr/>
            </p:nvGrpSpPr>
            <p:grpSpPr>
              <a:xfrm>
                <a:off x="1387255" y="3861542"/>
                <a:ext cx="6065064" cy="2292096"/>
                <a:chOff x="1387255" y="3861542"/>
                <a:chExt cx="6065064" cy="2292096"/>
              </a:xfrm>
            </p:grpSpPr>
            <p:grpSp>
              <p:nvGrpSpPr>
                <p:cNvPr id="18" name="Группа 17"/>
                <p:cNvGrpSpPr/>
                <p:nvPr/>
              </p:nvGrpSpPr>
              <p:grpSpPr>
                <a:xfrm>
                  <a:off x="1387255" y="3861542"/>
                  <a:ext cx="6065064" cy="2292096"/>
                  <a:chOff x="1362416" y="3889248"/>
                  <a:chExt cx="6089904" cy="2292096"/>
                </a:xfrm>
              </p:grpSpPr>
              <p:grpSp>
                <p:nvGrpSpPr>
                  <p:cNvPr id="17" name="Группа 16"/>
                  <p:cNvGrpSpPr/>
                  <p:nvPr/>
                </p:nvGrpSpPr>
                <p:grpSpPr>
                  <a:xfrm>
                    <a:off x="1362416" y="3889248"/>
                    <a:ext cx="6089904" cy="2292096"/>
                    <a:chOff x="1426464" y="3889248"/>
                    <a:chExt cx="6089904" cy="2292096"/>
                  </a:xfrm>
                </p:grpSpPr>
                <p:sp>
                  <p:nvSpPr>
                    <p:cNvPr id="16" name="Прямоугольник 15"/>
                    <p:cNvSpPr/>
                    <p:nvPr/>
                  </p:nvSpPr>
                  <p:spPr>
                    <a:xfrm>
                      <a:off x="1426464" y="3889248"/>
                      <a:ext cx="6089904" cy="2292096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 w="317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ru-RU"/>
                    </a:p>
                  </p:txBody>
                </p:sp>
                <p:grpSp>
                  <p:nvGrpSpPr>
                    <p:cNvPr id="15" name="Группа 14"/>
                    <p:cNvGrpSpPr/>
                    <p:nvPr/>
                  </p:nvGrpSpPr>
                  <p:grpSpPr>
                    <a:xfrm>
                      <a:off x="3051873" y="4028275"/>
                      <a:ext cx="3621442" cy="2020139"/>
                      <a:chOff x="3051873" y="4028275"/>
                      <a:chExt cx="3621442" cy="2020139"/>
                    </a:xfrm>
                  </p:grpSpPr>
                  <p:sp>
                    <p:nvSpPr>
                      <p:cNvPr id="2" name="TextBox 1"/>
                      <p:cNvSpPr txBox="1"/>
                      <p:nvPr/>
                    </p:nvSpPr>
                    <p:spPr>
                      <a:xfrm>
                        <a:off x="5339617" y="4028275"/>
                        <a:ext cx="1333698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lIns="0" tIns="0" rIns="0" bIns="0" rtlCol="0">
                        <a:spAutoFit/>
                      </a:bodyPr>
                      <a:lstStyle/>
                      <a:p>
                        <a:pPr algn="just"/>
                        <a:r>
                          <a:rPr lang="en-US" sz="14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Aluminum alloy</a:t>
                        </a:r>
                        <a:endParaRPr lang="ru-RU" b="1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sp>
                    <p:nvSpPr>
                      <p:cNvPr id="9" name="TextBox 8"/>
                      <p:cNvSpPr txBox="1"/>
                      <p:nvPr/>
                    </p:nvSpPr>
                    <p:spPr>
                      <a:xfrm>
                        <a:off x="3051873" y="5832970"/>
                        <a:ext cx="772584" cy="21544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lIns="0" tIns="0" rIns="0" bIns="0" rtlCol="0">
                        <a:spAutoFit/>
                      </a:bodyPr>
                      <a:lstStyle/>
                      <a:p>
                        <a:pPr algn="just"/>
                        <a:r>
                          <a:rPr lang="en-US" sz="14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Ti-6Al-4V</a:t>
                        </a:r>
                        <a:endParaRPr lang="ru-RU" b="1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</p:grpSp>
              </p:grpSp>
              <p:sp>
                <p:nvSpPr>
                  <p:cNvPr id="20" name="TextBox 19"/>
                  <p:cNvSpPr txBox="1"/>
                  <p:nvPr/>
                </p:nvSpPr>
                <p:spPr>
                  <a:xfrm>
                    <a:off x="1387256" y="3937897"/>
                    <a:ext cx="327013" cy="307777"/>
                  </a:xfrm>
                  <a:prstGeom prst="rect">
                    <a:avLst/>
                  </a:prstGeom>
                  <a:noFill/>
                </p:spPr>
                <p:txBody>
                  <a:bodyPr wrap="none" lIns="0" tIns="0" rIns="0" bIns="0" rtlCol="0">
                    <a:spAutoFit/>
                  </a:bodyPr>
                  <a:lstStyle/>
                  <a:p>
                    <a:pPr algn="just"/>
                    <a:r>
                      <a:rPr lang="en-US" sz="2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b)</a:t>
                    </a:r>
                    <a:endParaRPr lang="ru-RU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pic>
              <p:nvPicPr>
                <p:cNvPr id="4" name="Рисунок 3">
                  <a:extLst>
                    <a:ext uri="{FF2B5EF4-FFF2-40B4-BE49-F238E27FC236}">
                      <a16:creationId xmlns:a16="http://schemas.microsoft.com/office/drawing/2014/main" id="{BB6B782B-8A54-4F5E-93D6-6922FFDDD5E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 rot="5400000">
                  <a:off x="3525866" y="2257391"/>
                  <a:ext cx="1572768" cy="5522976"/>
                </a:xfrm>
                <a:prstGeom prst="rect">
                  <a:avLst/>
                </a:prstGeom>
              </p:spPr>
            </p:pic>
          </p:grpSp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CE61D923-9FE4-45B1-A47B-4E4214333F63}"/>
                  </a:ext>
                </a:extLst>
              </p:cNvPr>
              <p:cNvSpPr txBox="1"/>
              <p:nvPr/>
            </p:nvSpPr>
            <p:spPr>
              <a:xfrm>
                <a:off x="3419872" y="4765431"/>
                <a:ext cx="50405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S</a:t>
                </a:r>
                <a:endParaRPr lang="ru-RU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EB8E4EC1-CF8F-48EC-B98C-072D29689D6F}"/>
                  </a:ext>
                </a:extLst>
              </p:cNvPr>
              <p:cNvSpPr txBox="1"/>
              <p:nvPr/>
            </p:nvSpPr>
            <p:spPr>
              <a:xfrm>
                <a:off x="4788024" y="4765431"/>
                <a:ext cx="50405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S</a:t>
                </a:r>
                <a:endParaRPr lang="ru-RU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9" name="Прямая со стрелкой 18">
                <a:extLst>
                  <a:ext uri="{FF2B5EF4-FFF2-40B4-BE49-F238E27FC236}">
                    <a16:creationId xmlns:a16="http://schemas.microsoft.com/office/drawing/2014/main" id="{B2EE169D-2214-4C32-8AB7-9F3631BE46A9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5403408" y="4271247"/>
                <a:ext cx="155925" cy="648072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triangle" w="med" len="lg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Прямая со стрелкой 26">
                <a:extLst>
                  <a:ext uri="{FF2B5EF4-FFF2-40B4-BE49-F238E27FC236}">
                    <a16:creationId xmlns:a16="http://schemas.microsoft.com/office/drawing/2014/main" id="{3B470F79-C437-4A8D-AA08-CBC599232986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400132" y="5243061"/>
                <a:ext cx="201503" cy="504056"/>
              </a:xfrm>
              <a:prstGeom prst="straightConnector1">
                <a:avLst/>
              </a:prstGeom>
              <a:ln w="28575">
                <a:tailEnd type="triangle" w="med" len="lg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286019731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Группа 5"/>
          <p:cNvGrpSpPr/>
          <p:nvPr/>
        </p:nvGrpSpPr>
        <p:grpSpPr>
          <a:xfrm>
            <a:off x="-13855" y="-13855"/>
            <a:ext cx="9171710" cy="6650182"/>
            <a:chOff x="-13855" y="-13855"/>
            <a:chExt cx="9171710" cy="6650182"/>
          </a:xfrm>
        </p:grpSpPr>
        <p:sp>
          <p:nvSpPr>
            <p:cNvPr id="5" name="Прямоугольник 4"/>
            <p:cNvSpPr/>
            <p:nvPr/>
          </p:nvSpPr>
          <p:spPr>
            <a:xfrm>
              <a:off x="-13855" y="-13855"/>
              <a:ext cx="9171710" cy="665018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ru-RU"/>
            </a:p>
          </p:txBody>
        </p:sp>
        <p:grpSp>
          <p:nvGrpSpPr>
            <p:cNvPr id="4" name="Группа 3"/>
            <p:cNvGrpSpPr/>
            <p:nvPr/>
          </p:nvGrpSpPr>
          <p:grpSpPr>
            <a:xfrm>
              <a:off x="35496" y="-5085"/>
              <a:ext cx="9073008" cy="6567302"/>
              <a:chOff x="35496" y="-5085"/>
              <a:chExt cx="9073008" cy="6567302"/>
            </a:xfrm>
          </p:grpSpPr>
          <p:sp>
            <p:nvSpPr>
              <p:cNvPr id="2" name="TextBox 1"/>
              <p:cNvSpPr txBox="1"/>
              <p:nvPr/>
            </p:nvSpPr>
            <p:spPr>
              <a:xfrm>
                <a:off x="2383138" y="-5085"/>
                <a:ext cx="4475712" cy="3077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2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ommercial aluminum alloy AA6013 </a:t>
                </a:r>
                <a:endParaRPr lang="ru-RU" sz="2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aphicFrame>
            <p:nvGraphicFramePr>
              <p:cNvPr id="3" name="Объект 2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85502925"/>
                  </p:ext>
                </p:extLst>
              </p:nvPr>
            </p:nvGraphicFramePr>
            <p:xfrm>
              <a:off x="35496" y="470795"/>
              <a:ext cx="2261559" cy="16920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114" name="SPW 11.0 Graph" r:id="rId4" imgW="5597640" imgH="4188240" progId="SigmaPlotGraphicObject.10">
                      <p:embed/>
                    </p:oleObj>
                  </mc:Choice>
                  <mc:Fallback>
                    <p:oleObj name="SPW 11.0 Graph" r:id="rId4" imgW="5597640" imgH="4188240" progId="SigmaPlotGraphicObject.10">
                      <p:embed/>
                      <p:pic>
                        <p:nvPicPr>
                          <p:cNvPr id="13" name="Объект 12"/>
                          <p:cNvPicPr/>
                          <p:nvPr/>
                        </p:nvPicPr>
                        <p:blipFill>
                          <a:blip r:embed="rId5"/>
                          <a:stretch>
                            <a:fillRect/>
                          </a:stretch>
                        </p:blipFill>
                        <p:spPr>
                          <a:xfrm>
                            <a:off x="35496" y="470795"/>
                            <a:ext cx="2261559" cy="1692000"/>
                          </a:xfrm>
                          <a:prstGeom prst="rect">
                            <a:avLst/>
                          </a:prstGeom>
                          <a:ln w="3175">
                            <a:solidFill>
                              <a:schemeClr val="tx1"/>
                            </a:solidFill>
                          </a:ln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10" name="Объект 9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414677205"/>
                  </p:ext>
                </p:extLst>
              </p:nvPr>
            </p:nvGraphicFramePr>
            <p:xfrm>
              <a:off x="2382448" y="471078"/>
              <a:ext cx="2261560" cy="16920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115" name="SPW 11.0 Graph" r:id="rId6" imgW="5597640" imgH="4188240" progId="SigmaPlotGraphicObject.10">
                      <p:embed/>
                    </p:oleObj>
                  </mc:Choice>
                  <mc:Fallback>
                    <p:oleObj name="SPW 11.0 Graph" r:id="rId6" imgW="5597640" imgH="4188240" progId="SigmaPlotGraphicObject.10">
                      <p:embed/>
                      <p:pic>
                        <p:nvPicPr>
                          <p:cNvPr id="4" name="Объект 3"/>
                          <p:cNvPicPr/>
                          <p:nvPr/>
                        </p:nvPicPr>
                        <p:blipFill>
                          <a:blip r:embed="rId7"/>
                          <a:stretch>
                            <a:fillRect/>
                          </a:stretch>
                        </p:blipFill>
                        <p:spPr>
                          <a:xfrm>
                            <a:off x="2382448" y="471078"/>
                            <a:ext cx="2261560" cy="1692000"/>
                          </a:xfrm>
                          <a:prstGeom prst="rect">
                            <a:avLst/>
                          </a:prstGeom>
                          <a:ln w="3175">
                            <a:solidFill>
                              <a:schemeClr val="tx1"/>
                            </a:solidFill>
                          </a:ln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11" name="Объект 10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546365628"/>
                  </p:ext>
                </p:extLst>
              </p:nvPr>
            </p:nvGraphicFramePr>
            <p:xfrm>
              <a:off x="4731758" y="471078"/>
              <a:ext cx="2144498" cy="16920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116" name="SPW 11.0 Graph" r:id="rId8" imgW="5597640" imgH="4416840" progId="SigmaPlotGraphicObject.10">
                      <p:embed/>
                    </p:oleObj>
                  </mc:Choice>
                  <mc:Fallback>
                    <p:oleObj name="SPW 11.0 Graph" r:id="rId8" imgW="5597640" imgH="4416840" progId="SigmaPlotGraphicObject.10">
                      <p:embed/>
                      <p:pic>
                        <p:nvPicPr>
                          <p:cNvPr id="34" name="Объект 33"/>
                          <p:cNvPicPr/>
                          <p:nvPr/>
                        </p:nvPicPr>
                        <p:blipFill>
                          <a:blip r:embed="rId9"/>
                          <a:stretch>
                            <a:fillRect/>
                          </a:stretch>
                        </p:blipFill>
                        <p:spPr>
                          <a:xfrm>
                            <a:off x="4731758" y="471078"/>
                            <a:ext cx="2144498" cy="1692000"/>
                          </a:xfrm>
                          <a:prstGeom prst="rect">
                            <a:avLst/>
                          </a:prstGeom>
                          <a:ln w="3175">
                            <a:solidFill>
                              <a:schemeClr val="tx1"/>
                            </a:solidFill>
                          </a:ln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12" name="Объект 11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129917622"/>
                  </p:ext>
                </p:extLst>
              </p:nvPr>
            </p:nvGraphicFramePr>
            <p:xfrm>
              <a:off x="6964006" y="471078"/>
              <a:ext cx="2144498" cy="16920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117" name="SPW 11.0 Graph" r:id="rId10" imgW="5597640" imgH="4416840" progId="SigmaPlotGraphicObject.10">
                      <p:embed/>
                    </p:oleObj>
                  </mc:Choice>
                  <mc:Fallback>
                    <p:oleObj name="SPW 11.0 Graph" r:id="rId10" imgW="5597640" imgH="4416840" progId="SigmaPlotGraphicObject.10">
                      <p:embed/>
                      <p:pic>
                        <p:nvPicPr>
                          <p:cNvPr id="27" name="Объект 26"/>
                          <p:cNvPicPr/>
                          <p:nvPr/>
                        </p:nvPicPr>
                        <p:blipFill>
                          <a:blip r:embed="rId11"/>
                          <a:stretch>
                            <a:fillRect/>
                          </a:stretch>
                        </p:blipFill>
                        <p:spPr>
                          <a:xfrm>
                            <a:off x="6964006" y="471078"/>
                            <a:ext cx="2144498" cy="1692000"/>
                          </a:xfrm>
                          <a:prstGeom prst="rect">
                            <a:avLst/>
                          </a:prstGeom>
                          <a:ln w="3175">
                            <a:solidFill>
                              <a:schemeClr val="tx1"/>
                            </a:solidFill>
                          </a:ln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13" name="TextBox 12"/>
              <p:cNvSpPr txBox="1"/>
              <p:nvPr/>
            </p:nvSpPr>
            <p:spPr>
              <a:xfrm>
                <a:off x="250754" y="260648"/>
                <a:ext cx="1885131" cy="1692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Welding speed 12.7 mm/min</a:t>
                </a:r>
                <a:endParaRPr lang="ru-RU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2544842" y="262278"/>
                <a:ext cx="1885131" cy="1692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Welding speed 25.4 mm/min</a:t>
                </a:r>
                <a:endParaRPr lang="ru-RU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4872031" y="262278"/>
                <a:ext cx="1885131" cy="1692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Welding speed 50.8 mm/min</a:t>
                </a:r>
                <a:endParaRPr lang="ru-RU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7112723" y="262278"/>
                <a:ext cx="1885131" cy="1692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Welding speed 76.2 mm/min</a:t>
                </a:r>
                <a:endParaRPr lang="ru-RU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1979712" y="2204864"/>
                <a:ext cx="5576976" cy="3077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2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Experimental aluminum alloy AA6013 + 2.0 Si </a:t>
                </a:r>
                <a:endParaRPr lang="ru-RU" sz="2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aphicFrame>
            <p:nvGraphicFramePr>
              <p:cNvPr id="18" name="Объект 17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92412462"/>
                  </p:ext>
                </p:extLst>
              </p:nvPr>
            </p:nvGraphicFramePr>
            <p:xfrm>
              <a:off x="45106" y="2710266"/>
              <a:ext cx="2144498" cy="16920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118" name="SPW 11.0 Graph" r:id="rId12" imgW="5597640" imgH="4416840" progId="SigmaPlotGraphicObject.10">
                      <p:embed/>
                    </p:oleObj>
                  </mc:Choice>
                  <mc:Fallback>
                    <p:oleObj name="SPW 11.0 Graph" r:id="rId12" imgW="5597640" imgH="4416840" progId="SigmaPlotGraphicObject.10">
                      <p:embed/>
                      <p:pic>
                        <p:nvPicPr>
                          <p:cNvPr id="19" name="Объект 18"/>
                          <p:cNvPicPr/>
                          <p:nvPr/>
                        </p:nvPicPr>
                        <p:blipFill>
                          <a:blip r:embed="rId13"/>
                          <a:stretch>
                            <a:fillRect/>
                          </a:stretch>
                        </p:blipFill>
                        <p:spPr>
                          <a:xfrm>
                            <a:off x="45106" y="2710266"/>
                            <a:ext cx="2144498" cy="1692000"/>
                          </a:xfrm>
                          <a:prstGeom prst="rect">
                            <a:avLst/>
                          </a:prstGeom>
                          <a:ln w="3175">
                            <a:solidFill>
                              <a:schemeClr val="tx1"/>
                            </a:solidFill>
                          </a:ln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19" name="Объект 18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554255147"/>
                  </p:ext>
                </p:extLst>
              </p:nvPr>
            </p:nvGraphicFramePr>
            <p:xfrm>
              <a:off x="2305876" y="2708929"/>
              <a:ext cx="2144498" cy="16920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119" name="SPW 11.0 Graph" r:id="rId14" imgW="5597640" imgH="4416840" progId="SigmaPlotGraphicObject.10">
                      <p:embed/>
                    </p:oleObj>
                  </mc:Choice>
                  <mc:Fallback>
                    <p:oleObj name="SPW 11.0 Graph" r:id="rId14" imgW="5597640" imgH="4416840" progId="SigmaPlotGraphicObject.10">
                      <p:embed/>
                      <p:pic>
                        <p:nvPicPr>
                          <p:cNvPr id="22" name="Объект 21"/>
                          <p:cNvPicPr/>
                          <p:nvPr/>
                        </p:nvPicPr>
                        <p:blipFill>
                          <a:blip r:embed="rId15"/>
                          <a:stretch>
                            <a:fillRect/>
                          </a:stretch>
                        </p:blipFill>
                        <p:spPr>
                          <a:xfrm>
                            <a:off x="2305876" y="2708929"/>
                            <a:ext cx="2144498" cy="1692000"/>
                          </a:xfrm>
                          <a:prstGeom prst="rect">
                            <a:avLst/>
                          </a:prstGeom>
                          <a:ln w="3175">
                            <a:solidFill>
                              <a:schemeClr val="tx1"/>
                            </a:solidFill>
                          </a:ln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20" name="Объект 19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756055561"/>
                  </p:ext>
                </p:extLst>
              </p:nvPr>
            </p:nvGraphicFramePr>
            <p:xfrm>
              <a:off x="4599200" y="2708929"/>
              <a:ext cx="2144498" cy="16920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120" name="SPW 11.0 Graph" r:id="rId16" imgW="5597640" imgH="4416840" progId="SigmaPlotGraphicObject.10">
                      <p:embed/>
                    </p:oleObj>
                  </mc:Choice>
                  <mc:Fallback>
                    <p:oleObj name="SPW 11.0 Graph" r:id="rId16" imgW="5597640" imgH="4416840" progId="SigmaPlotGraphicObject.10">
                      <p:embed/>
                      <p:pic>
                        <p:nvPicPr>
                          <p:cNvPr id="25" name="Объект 24"/>
                          <p:cNvPicPr/>
                          <p:nvPr/>
                        </p:nvPicPr>
                        <p:blipFill>
                          <a:blip r:embed="rId17"/>
                          <a:stretch>
                            <a:fillRect/>
                          </a:stretch>
                        </p:blipFill>
                        <p:spPr>
                          <a:xfrm>
                            <a:off x="4599200" y="2708929"/>
                            <a:ext cx="2144498" cy="1692000"/>
                          </a:xfrm>
                          <a:prstGeom prst="rect">
                            <a:avLst/>
                          </a:prstGeom>
                          <a:ln w="3175">
                            <a:solidFill>
                              <a:schemeClr val="tx1"/>
                            </a:solidFill>
                          </a:ln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21" name="Объект 20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105658211"/>
                  </p:ext>
                </p:extLst>
              </p:nvPr>
            </p:nvGraphicFramePr>
            <p:xfrm>
              <a:off x="6886130" y="2708929"/>
              <a:ext cx="2144498" cy="16920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121" name="SPW 11.0 Graph" r:id="rId18" imgW="5597640" imgH="4416840" progId="SigmaPlotGraphicObject.10">
                      <p:embed/>
                    </p:oleObj>
                  </mc:Choice>
                  <mc:Fallback>
                    <p:oleObj name="SPW 11.0 Graph" r:id="rId18" imgW="5597640" imgH="4416840" progId="SigmaPlotGraphicObject.10">
                      <p:embed/>
                      <p:pic>
                        <p:nvPicPr>
                          <p:cNvPr id="17" name="Объект 16"/>
                          <p:cNvPicPr/>
                          <p:nvPr/>
                        </p:nvPicPr>
                        <p:blipFill>
                          <a:blip r:embed="rId19"/>
                          <a:stretch>
                            <a:fillRect/>
                          </a:stretch>
                        </p:blipFill>
                        <p:spPr>
                          <a:xfrm>
                            <a:off x="6886130" y="2708929"/>
                            <a:ext cx="2144498" cy="1692000"/>
                          </a:xfrm>
                          <a:prstGeom prst="rect">
                            <a:avLst/>
                          </a:prstGeom>
                          <a:ln w="3175">
                            <a:solidFill>
                              <a:schemeClr val="tx1"/>
                            </a:solidFill>
                          </a:ln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22" name="TextBox 21"/>
              <p:cNvSpPr txBox="1"/>
              <p:nvPr/>
            </p:nvSpPr>
            <p:spPr>
              <a:xfrm>
                <a:off x="217803" y="2532529"/>
                <a:ext cx="1885131" cy="1692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Welding speed 12.7 mm/min</a:t>
                </a:r>
                <a:endParaRPr lang="ru-RU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2511890" y="2532529"/>
                <a:ext cx="1885131" cy="1692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Welding speed 25.4 mm/min</a:t>
                </a:r>
                <a:endParaRPr lang="ru-RU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4826723" y="2532529"/>
                <a:ext cx="1885131" cy="1692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Welding speed 50.8 mm/min</a:t>
                </a:r>
                <a:endParaRPr lang="ru-RU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7079772" y="2532529"/>
                <a:ext cx="1885131" cy="1692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Welding speed 76.2 mm/min</a:t>
                </a:r>
                <a:endParaRPr lang="ru-RU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>
                <a:off x="1187624" y="4437112"/>
                <a:ext cx="6663812" cy="3077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2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Experimental aluminum alloy AA6013 + 0.8 Si + 1.0 Mg </a:t>
                </a:r>
                <a:endParaRPr lang="ru-RU" sz="2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aphicFrame>
            <p:nvGraphicFramePr>
              <p:cNvPr id="27" name="Объект 26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51628643"/>
                  </p:ext>
                </p:extLst>
              </p:nvPr>
            </p:nvGraphicFramePr>
            <p:xfrm>
              <a:off x="67330" y="4869160"/>
              <a:ext cx="2241169" cy="16920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122" name="SPW 11.0 Graph" r:id="rId20" imgW="5597640" imgH="4226400" progId="SigmaPlotGraphicObject.10">
                      <p:embed/>
                    </p:oleObj>
                  </mc:Choice>
                  <mc:Fallback>
                    <p:oleObj name="SPW 11.0 Graph" r:id="rId20" imgW="5597640" imgH="4226400" progId="SigmaPlotGraphicObject.10">
                      <p:embed/>
                      <p:pic>
                        <p:nvPicPr>
                          <p:cNvPr id="29" name="Объект 28"/>
                          <p:cNvPicPr/>
                          <p:nvPr/>
                        </p:nvPicPr>
                        <p:blipFill>
                          <a:blip r:embed="rId21"/>
                          <a:stretch>
                            <a:fillRect/>
                          </a:stretch>
                        </p:blipFill>
                        <p:spPr>
                          <a:xfrm>
                            <a:off x="67330" y="4869160"/>
                            <a:ext cx="2241169" cy="1692000"/>
                          </a:xfrm>
                          <a:prstGeom prst="rect">
                            <a:avLst/>
                          </a:prstGeom>
                          <a:ln w="3175">
                            <a:solidFill>
                              <a:schemeClr val="tx1"/>
                            </a:solidFill>
                          </a:ln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28" name="Объект 27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062471531"/>
                  </p:ext>
                </p:extLst>
              </p:nvPr>
            </p:nvGraphicFramePr>
            <p:xfrm>
              <a:off x="2423166" y="4870217"/>
              <a:ext cx="2147585" cy="16920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123" name="SPW 11.0 Graph" r:id="rId22" imgW="5597640" imgH="4410720" progId="SigmaPlotGraphicObject.10">
                      <p:embed/>
                    </p:oleObj>
                  </mc:Choice>
                  <mc:Fallback>
                    <p:oleObj name="SPW 11.0 Graph" r:id="rId22" imgW="5597640" imgH="4410720" progId="SigmaPlotGraphicObject.10">
                      <p:embed/>
                      <p:pic>
                        <p:nvPicPr>
                          <p:cNvPr id="32" name="Объект 31"/>
                          <p:cNvPicPr/>
                          <p:nvPr/>
                        </p:nvPicPr>
                        <p:blipFill>
                          <a:blip r:embed="rId23"/>
                          <a:stretch>
                            <a:fillRect/>
                          </a:stretch>
                        </p:blipFill>
                        <p:spPr>
                          <a:xfrm>
                            <a:off x="2423166" y="4870217"/>
                            <a:ext cx="2147585" cy="1692000"/>
                          </a:xfrm>
                          <a:prstGeom prst="rect">
                            <a:avLst/>
                          </a:prstGeom>
                          <a:ln w="3175">
                            <a:solidFill>
                              <a:schemeClr val="tx1"/>
                            </a:solidFill>
                          </a:ln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29" name="Объект 28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660436673"/>
                  </p:ext>
                </p:extLst>
              </p:nvPr>
            </p:nvGraphicFramePr>
            <p:xfrm>
              <a:off x="4704911" y="4870217"/>
              <a:ext cx="2144498" cy="16920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124" name="SPW 11.0 Graph" r:id="rId24" imgW="5597640" imgH="4416840" progId="SigmaPlotGraphicObject.10">
                      <p:embed/>
                    </p:oleObj>
                  </mc:Choice>
                  <mc:Fallback>
                    <p:oleObj name="SPW 11.0 Graph" r:id="rId24" imgW="5597640" imgH="4416840" progId="SigmaPlotGraphicObject.10">
                      <p:embed/>
                      <p:pic>
                        <p:nvPicPr>
                          <p:cNvPr id="15" name="Объект 14"/>
                          <p:cNvPicPr/>
                          <p:nvPr/>
                        </p:nvPicPr>
                        <p:blipFill>
                          <a:blip r:embed="rId25"/>
                          <a:stretch>
                            <a:fillRect/>
                          </a:stretch>
                        </p:blipFill>
                        <p:spPr>
                          <a:xfrm>
                            <a:off x="4704911" y="4870217"/>
                            <a:ext cx="2144498" cy="1692000"/>
                          </a:xfrm>
                          <a:prstGeom prst="rect">
                            <a:avLst/>
                          </a:prstGeom>
                          <a:ln w="3175">
                            <a:solidFill>
                              <a:schemeClr val="tx1"/>
                            </a:solidFill>
                          </a:ln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30" name="Объект 29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4182120885"/>
                  </p:ext>
                </p:extLst>
              </p:nvPr>
            </p:nvGraphicFramePr>
            <p:xfrm>
              <a:off x="6950717" y="4870217"/>
              <a:ext cx="2144498" cy="16920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125" name="SPW 11.0 Graph" r:id="rId26" imgW="5597640" imgH="4416840" progId="SigmaPlotGraphicObject.10">
                      <p:embed/>
                    </p:oleObj>
                  </mc:Choice>
                  <mc:Fallback>
                    <p:oleObj name="SPW 11.0 Graph" r:id="rId26" imgW="5597640" imgH="4416840" progId="SigmaPlotGraphicObject.10">
                      <p:embed/>
                      <p:pic>
                        <p:nvPicPr>
                          <p:cNvPr id="36" name="Объект 35"/>
                          <p:cNvPicPr/>
                          <p:nvPr/>
                        </p:nvPicPr>
                        <p:blipFill>
                          <a:blip r:embed="rId27"/>
                          <a:stretch>
                            <a:fillRect/>
                          </a:stretch>
                        </p:blipFill>
                        <p:spPr>
                          <a:xfrm>
                            <a:off x="6950717" y="4870217"/>
                            <a:ext cx="2144498" cy="1692000"/>
                          </a:xfrm>
                          <a:prstGeom prst="rect">
                            <a:avLst/>
                          </a:prstGeom>
                          <a:ln w="3175">
                            <a:solidFill>
                              <a:schemeClr val="tx1"/>
                            </a:solidFill>
                          </a:ln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31" name="TextBox 30"/>
              <p:cNvSpPr txBox="1"/>
              <p:nvPr/>
            </p:nvSpPr>
            <p:spPr>
              <a:xfrm>
                <a:off x="322076" y="4706235"/>
                <a:ext cx="1885131" cy="1692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Welding speed 12.7 mm/min</a:t>
                </a:r>
                <a:endParaRPr lang="ru-RU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2551995" y="4706234"/>
                <a:ext cx="1885131" cy="1692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Welding speed 25.4 mm/min</a:t>
                </a:r>
                <a:endParaRPr lang="ru-RU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>
                <a:off x="4898913" y="4706234"/>
                <a:ext cx="1885131" cy="1692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Welding speed 50.8 mm/min</a:t>
                </a:r>
                <a:endParaRPr lang="ru-RU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7119878" y="4705200"/>
                <a:ext cx="1885131" cy="169277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11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Welding speed 76.2 mm/min</a:t>
                </a:r>
                <a:endParaRPr lang="ru-RU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36" name="TextBox 35"/>
          <p:cNvSpPr txBox="1"/>
          <p:nvPr/>
        </p:nvSpPr>
        <p:spPr>
          <a:xfrm>
            <a:off x="0" y="6622309"/>
            <a:ext cx="9153474" cy="200055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3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sz="13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sz="13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sz="1300" dirty="0" smtClean="0">
                <a:latin typeface="Arial" panose="020B0604020202020204" pitchFamily="34" charset="0"/>
                <a:cs typeface="Arial" panose="020B0604020202020204" pitchFamily="34" charset="0"/>
              </a:rPr>
              <a:t>. The entire set of deformation diagrams recorded during lap=shear tests</a:t>
            </a:r>
            <a:endParaRPr lang="en-US" sz="1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14902733"/>
      </p:ext>
    </p:extLst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Стандартная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Стандартная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1</TotalTime>
  <Words>188</Words>
  <Application>Microsoft Office PowerPoint</Application>
  <PresentationFormat>Экран (4:3)</PresentationFormat>
  <Paragraphs>33</Paragraphs>
  <Slides>5</Slides>
  <Notes>1</Notes>
  <HiddenSlides>0</HiddenSlides>
  <MMClips>0</MMClips>
  <ScaleCrop>false</ScaleCrop>
  <HeadingPairs>
    <vt:vector size="8" baseType="variant">
      <vt:variant>
        <vt:lpstr>Использованные шрифты</vt:lpstr>
      </vt:variant>
      <vt:variant>
        <vt:i4>2</vt:i4>
      </vt:variant>
      <vt:variant>
        <vt:lpstr>Тема</vt:lpstr>
      </vt:variant>
      <vt:variant>
        <vt:i4>1</vt:i4>
      </vt:variant>
      <vt:variant>
        <vt:lpstr>Внедренные серверы OLE</vt:lpstr>
      </vt:variant>
      <vt:variant>
        <vt:i4>1</vt:i4>
      </vt:variant>
      <vt:variant>
        <vt:lpstr>Заголовки слайдов</vt:lpstr>
      </vt:variant>
      <vt:variant>
        <vt:i4>5</vt:i4>
      </vt:variant>
    </vt:vector>
  </HeadingPairs>
  <TitlesOfParts>
    <vt:vector size="9" baseType="lpstr">
      <vt:lpstr>Arial</vt:lpstr>
      <vt:lpstr>Calibri</vt:lpstr>
      <vt:lpstr>Тема Office</vt:lpstr>
      <vt:lpstr>SPW 11.0 Graph</vt:lpstr>
      <vt:lpstr>Презентация PowerPoint</vt:lpstr>
      <vt:lpstr>Презентация PowerPoint</vt:lpstr>
      <vt:lpstr>Презентация PowerPoint</vt:lpstr>
      <vt:lpstr>Презентация PowerPoint</vt:lpstr>
      <vt:lpstr>Презентация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Sergey</dc:creator>
  <cp:lastModifiedBy>Пользователь Windows</cp:lastModifiedBy>
  <cp:revision>14</cp:revision>
  <dcterms:created xsi:type="dcterms:W3CDTF">2022-10-11T12:22:43Z</dcterms:created>
  <dcterms:modified xsi:type="dcterms:W3CDTF">2022-11-12T14:57:46Z</dcterms:modified>
</cp:coreProperties>
</file>